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553" autoAdjust="0"/>
    <p:restoredTop sz="96353" autoAdjust="0"/>
  </p:normalViewPr>
  <p:slideViewPr>
    <p:cSldViewPr snapToGrid="0">
      <p:cViewPr>
        <p:scale>
          <a:sx n="210" d="100"/>
          <a:sy n="210" d="100"/>
        </p:scale>
        <p:origin x="960" y="-679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575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994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28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576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383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083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305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86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087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142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813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13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3CFFC742-5056-4504-B0CC-4D84B1F821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559" y="6090819"/>
            <a:ext cx="4113675" cy="1296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B84EDF5C-796E-4A97-BF26-E2C195FFF9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355" y="4471976"/>
            <a:ext cx="4106777" cy="1296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FA5C7F5-94DB-42FC-8256-B2FC42B3EC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567" y="2859369"/>
            <a:ext cx="4099902" cy="1296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0797E01-4ED8-4F19-A316-1F4BDF9DCB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275" y="1232601"/>
            <a:ext cx="4110233" cy="1296000"/>
          </a:xfrm>
          <a:prstGeom prst="rect">
            <a:avLst/>
          </a:prstGeom>
        </p:spPr>
      </p:pic>
      <p:sp>
        <p:nvSpPr>
          <p:cNvPr id="40" name="Text Box 385">
            <a:extLst>
              <a:ext uri="{FF2B5EF4-FFF2-40B4-BE49-F238E27FC236}">
                <a16:creationId xmlns:a16="http://schemas.microsoft.com/office/drawing/2014/main" id="{6F055B52-B8A9-4B14-834C-4A84174E03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128" y="7849901"/>
            <a:ext cx="5797191" cy="3856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25000"/>
              </a:lnSpc>
              <a:spcBef>
                <a:spcPct val="0"/>
              </a:spcBef>
              <a:buNone/>
              <a:defRPr/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 frequency of each marker in the ER-1 (A), ER-2 (B), ES-1 (C), and ES-2 (D) pools. The results are presented by scatter plots (left) and histograms (right).</a:t>
            </a:r>
            <a:endParaRPr lang="en-US" altLang="zh-CN" sz="8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AD7C44F3-D073-4A15-A010-711129E0A8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600" y="1082515"/>
            <a:ext cx="4148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750974E-E0D0-433C-8B83-EC8A62B4E8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600" y="4335139"/>
            <a:ext cx="4148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C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B63A978-41FA-4A4F-8EBD-E47806ECD1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55936" y="1284854"/>
            <a:ext cx="1771886" cy="1314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FC4DB9F-2CFC-4281-A4B5-C023E42273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54534" y="2907254"/>
            <a:ext cx="1763739" cy="1314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B0934BB-30F6-4692-91FC-DAA88434A4D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6122" y="4526059"/>
            <a:ext cx="1768141" cy="1314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ED8BE97-6CD6-49C9-B85A-E07E41C2A17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56762" y="6142675"/>
            <a:ext cx="1774744" cy="1314000"/>
          </a:xfrm>
          <a:prstGeom prst="rect">
            <a:avLst/>
          </a:prstGeom>
        </p:spPr>
      </p:pic>
      <p:sp>
        <p:nvSpPr>
          <p:cNvPr id="22" name="Rectangle 14">
            <a:extLst>
              <a:ext uri="{FF2B5EF4-FFF2-40B4-BE49-F238E27FC236}">
                <a16:creationId xmlns:a16="http://schemas.microsoft.com/office/drawing/2014/main" id="{F1517653-3816-4EFD-BB6D-AFBC7A315F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600" y="2716653"/>
            <a:ext cx="4148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B</a:t>
            </a:r>
          </a:p>
        </p:txBody>
      </p:sp>
      <p:sp>
        <p:nvSpPr>
          <p:cNvPr id="24" name="Rectangle 14">
            <a:extLst>
              <a:ext uri="{FF2B5EF4-FFF2-40B4-BE49-F238E27FC236}">
                <a16:creationId xmlns:a16="http://schemas.microsoft.com/office/drawing/2014/main" id="{5061F071-2989-43AB-8103-76B3B8EAF3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533" y="5950394"/>
            <a:ext cx="4148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b="1" dirty="0">
                <a:latin typeface="Times New Roman" panose="0202060305040502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3996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98</TotalTime>
  <Words>48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csb</cp:lastModifiedBy>
  <cp:revision>244</cp:revision>
  <cp:lastPrinted>2019-07-09T07:00:00Z</cp:lastPrinted>
  <dcterms:created xsi:type="dcterms:W3CDTF">2018-03-13T13:26:16Z</dcterms:created>
  <dcterms:modified xsi:type="dcterms:W3CDTF">2019-12-06T08:07:30Z</dcterms:modified>
</cp:coreProperties>
</file>